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7772400" cy="10058400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>
    <p:restoredLeft sz="7048" autoAdjust="0"/>
    <p:restoredTop sz="94641" autoAdjust="0"/>
  </p:normalViewPr>
  <p:slideViewPr>
    <p:cSldViewPr snapToGrid="0">
      <p:cViewPr varScale="1">
        <p:scale>
          <a:sx n="69" d="100"/>
          <a:sy n="69" d="100"/>
        </p:scale>
        <p:origin x="1920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63EC98-A86D-4C6D-B4AC-EEF3F2DE5562}" type="datetimeFigureOut">
              <a:rPr lang="en-US" smtClean="0"/>
              <a:t>6/2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3C24B6-A6CD-4EA1-AD15-65AEE8BE1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3698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63EC98-A86D-4C6D-B4AC-EEF3F2DE5562}" type="datetimeFigureOut">
              <a:rPr lang="en-US" smtClean="0"/>
              <a:t>6/2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3C24B6-A6CD-4EA1-AD15-65AEE8BE1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18554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63EC98-A86D-4C6D-B4AC-EEF3F2DE5562}" type="datetimeFigureOut">
              <a:rPr lang="en-US" smtClean="0"/>
              <a:t>6/2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3C24B6-A6CD-4EA1-AD15-65AEE8BE1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04230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63EC98-A86D-4C6D-B4AC-EEF3F2DE5562}" type="datetimeFigureOut">
              <a:rPr lang="en-US" smtClean="0"/>
              <a:t>6/2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3C24B6-A6CD-4EA1-AD15-65AEE8BE1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68740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63EC98-A86D-4C6D-B4AC-EEF3F2DE5562}" type="datetimeFigureOut">
              <a:rPr lang="en-US" smtClean="0"/>
              <a:t>6/2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3C24B6-A6CD-4EA1-AD15-65AEE8BE1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43004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63EC98-A86D-4C6D-B4AC-EEF3F2DE5562}" type="datetimeFigureOut">
              <a:rPr lang="en-US" smtClean="0"/>
              <a:t>6/2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3C24B6-A6CD-4EA1-AD15-65AEE8BE1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71229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63EC98-A86D-4C6D-B4AC-EEF3F2DE5562}" type="datetimeFigureOut">
              <a:rPr lang="en-US" smtClean="0"/>
              <a:t>6/25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3C24B6-A6CD-4EA1-AD15-65AEE8BE1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58524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63EC98-A86D-4C6D-B4AC-EEF3F2DE5562}" type="datetimeFigureOut">
              <a:rPr lang="en-US" smtClean="0"/>
              <a:t>6/25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3C24B6-A6CD-4EA1-AD15-65AEE8BE1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3217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63EC98-A86D-4C6D-B4AC-EEF3F2DE5562}" type="datetimeFigureOut">
              <a:rPr lang="en-US" smtClean="0"/>
              <a:t>6/25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3C24B6-A6CD-4EA1-AD15-65AEE8BE1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77021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63EC98-A86D-4C6D-B4AC-EEF3F2DE5562}" type="datetimeFigureOut">
              <a:rPr lang="en-US" smtClean="0"/>
              <a:t>6/2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3C24B6-A6CD-4EA1-AD15-65AEE8BE1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55939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63EC98-A86D-4C6D-B4AC-EEF3F2DE5562}" type="datetimeFigureOut">
              <a:rPr lang="en-US" smtClean="0"/>
              <a:t>6/2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3C24B6-A6CD-4EA1-AD15-65AEE8BE1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0898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63EC98-A86D-4C6D-B4AC-EEF3F2DE5562}" type="datetimeFigureOut">
              <a:rPr lang="en-US" smtClean="0"/>
              <a:t>6/2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3C24B6-A6CD-4EA1-AD15-65AEE8BE1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76810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62618" y="121331"/>
            <a:ext cx="4244009" cy="4244009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3362473" y="1043195"/>
            <a:ext cx="2779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Cambria" panose="02040503050406030204" pitchFamily="18" charset="0"/>
              </a:rPr>
              <a:t>ER positive tumors (n=2061)</a:t>
            </a:r>
            <a:endParaRPr lang="en-US" sz="1200" dirty="0">
              <a:latin typeface="Cambria" panose="020405030504060302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097915" y="149897"/>
            <a:ext cx="288083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Cambria" panose="02040503050406030204" pitchFamily="18" charset="0"/>
              </a:rPr>
              <a:t>	</a:t>
            </a:r>
            <a:r>
              <a:rPr lang="en-US" sz="1200" dirty="0" smtClean="0">
                <a:latin typeface="Cambria" panose="02040503050406030204" pitchFamily="18" charset="0"/>
              </a:rPr>
              <a:t>202286_s_at (TACSTD2)</a:t>
            </a:r>
            <a:endParaRPr lang="en-US" dirty="0">
              <a:latin typeface="Cambria" panose="020405030504060302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438031" y="8998855"/>
            <a:ext cx="503310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Cambria" panose="02040503050406030204" pitchFamily="18" charset="0"/>
              </a:rPr>
              <a:t>Additional file 10: Figure </a:t>
            </a:r>
            <a:r>
              <a:rPr lang="en-US" sz="1200" b="1" dirty="0" smtClean="0">
                <a:latin typeface="Cambria" panose="02040503050406030204" pitchFamily="18" charset="0"/>
              </a:rPr>
              <a:t>S4. Kaplan Meier plots stratified by ER status. </a:t>
            </a:r>
            <a:r>
              <a:rPr lang="en-US" sz="1200" dirty="0" smtClean="0">
                <a:latin typeface="Cambria" panose="02040503050406030204" pitchFamily="18" charset="0"/>
              </a:rPr>
              <a:t>ERpos tumors with lower TACSTD2 are associated with decreased survival (Top; p=0.018). ERneg tumors with lower TACSTD2 expression are associated with increased survival (Bottom; p=0.083).  </a:t>
            </a:r>
            <a:endParaRPr lang="en-US" sz="1200" b="1" dirty="0">
              <a:latin typeface="Cambria" panose="02040503050406030204" pitchFamily="18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62618" y="4540654"/>
            <a:ext cx="4242816" cy="4242816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2198113" y="4540654"/>
            <a:ext cx="3171825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Cambria" panose="02040503050406030204" pitchFamily="18" charset="0"/>
              </a:rPr>
              <a:t>	</a:t>
            </a:r>
            <a:r>
              <a:rPr lang="en-US" sz="1200" dirty="0" smtClean="0">
                <a:latin typeface="Cambria" panose="02040503050406030204" pitchFamily="18" charset="0"/>
              </a:rPr>
              <a:t>202286_s_at (TACSTD2)</a:t>
            </a:r>
            <a:endParaRPr lang="en-US" dirty="0">
              <a:latin typeface="Cambria" panose="020405030504060302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180522" y="5560071"/>
            <a:ext cx="22848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Cambria" panose="02040503050406030204" pitchFamily="18" charset="0"/>
              </a:rPr>
              <a:t>ER negative tumors (n=801)</a:t>
            </a:r>
            <a:endParaRPr lang="en-US" sz="1200" dirty="0">
              <a:latin typeface="Cambria" panose="020405030504060302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94756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4</TotalTime>
  <Words>58</Words>
  <Application>Microsoft Office PowerPoint</Application>
  <PresentationFormat>Custom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ambria</vt:lpstr>
      <vt:lpstr>Office Theme</vt:lpstr>
      <vt:lpstr>PowerPoint Presentation</vt:lpstr>
    </vt:vector>
  </TitlesOfParts>
  <Company>University of Massachusett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va Browne</dc:creator>
  <cp:lastModifiedBy>Eva Browne</cp:lastModifiedBy>
  <cp:revision>10</cp:revision>
  <cp:lastPrinted>2018-06-13T18:53:29Z</cp:lastPrinted>
  <dcterms:created xsi:type="dcterms:W3CDTF">2018-06-12T18:47:12Z</dcterms:created>
  <dcterms:modified xsi:type="dcterms:W3CDTF">2018-06-25T21:43:03Z</dcterms:modified>
</cp:coreProperties>
</file>